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68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AF2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BFF7928-83F0-45BC-AC2A-ED29C33B921D}" v="1" dt="2021-12-08T13:57:01.2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3"/>
    <p:restoredTop sz="94694"/>
  </p:normalViewPr>
  <p:slideViewPr>
    <p:cSldViewPr snapToGrid="0" snapToObjects="1">
      <p:cViewPr varScale="1">
        <p:scale>
          <a:sx n="115" d="100"/>
          <a:sy n="115" d="100"/>
        </p:scale>
        <p:origin x="2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ulholland,Michele Marie" userId="d51c45af-8c8f-43c3-83e8-815b5b504c0b" providerId="ADAL" clId="{038F1DF6-585C-4D8D-836C-52745E3D6DE4}"/>
    <pc:docChg chg="custSel addSld modSld sldOrd">
      <pc:chgData name="Mulholland,Michele Marie" userId="d51c45af-8c8f-43c3-83e8-815b5b504c0b" providerId="ADAL" clId="{038F1DF6-585C-4D8D-836C-52745E3D6DE4}" dt="2021-10-27T18:47:47.936" v="235" actId="20577"/>
      <pc:docMkLst>
        <pc:docMk/>
      </pc:docMkLst>
      <pc:sldChg chg="addSp delSp modSp">
        <pc:chgData name="Mulholland,Michele Marie" userId="d51c45af-8c8f-43c3-83e8-815b5b504c0b" providerId="ADAL" clId="{038F1DF6-585C-4D8D-836C-52745E3D6DE4}" dt="2021-10-27T18:45:27.686" v="65" actId="478"/>
        <pc:sldMkLst>
          <pc:docMk/>
          <pc:sldMk cId="2333212812" sldId="262"/>
        </pc:sldMkLst>
        <pc:spChg chg="add del mod">
          <ac:chgData name="Mulholland,Michele Marie" userId="d51c45af-8c8f-43c3-83e8-815b5b504c0b" providerId="ADAL" clId="{038F1DF6-585C-4D8D-836C-52745E3D6DE4}" dt="2021-10-27T18:45:27.686" v="65" actId="478"/>
          <ac:spMkLst>
            <pc:docMk/>
            <pc:sldMk cId="2333212812" sldId="262"/>
            <ac:spMk id="5" creationId="{A5485D4A-1956-4F60-8C82-0C134146C15D}"/>
          </ac:spMkLst>
        </pc:spChg>
      </pc:sldChg>
      <pc:sldChg chg="addSp delSp modSp add ord">
        <pc:chgData name="Mulholland,Michele Marie" userId="d51c45af-8c8f-43c3-83e8-815b5b504c0b" providerId="ADAL" clId="{038F1DF6-585C-4D8D-836C-52745E3D6DE4}" dt="2021-10-27T18:47:47.936" v="235" actId="20577"/>
        <pc:sldMkLst>
          <pc:docMk/>
          <pc:sldMk cId="3454629042" sldId="268"/>
        </pc:sldMkLst>
        <pc:spChg chg="mod">
          <ac:chgData name="Mulholland,Michele Marie" userId="d51c45af-8c8f-43c3-83e8-815b5b504c0b" providerId="ADAL" clId="{038F1DF6-585C-4D8D-836C-52745E3D6DE4}" dt="2021-10-27T18:43:45.976" v="53" actId="20577"/>
          <ac:spMkLst>
            <pc:docMk/>
            <pc:sldMk cId="3454629042" sldId="268"/>
            <ac:spMk id="2" creationId="{12886A07-7D58-44A4-AB4A-C19E3F518A0B}"/>
          </ac:spMkLst>
        </pc:spChg>
        <pc:spChg chg="add del mod">
          <ac:chgData name="Mulholland,Michele Marie" userId="d51c45af-8c8f-43c3-83e8-815b5b504c0b" providerId="ADAL" clId="{038F1DF6-585C-4D8D-836C-52745E3D6DE4}" dt="2021-10-27T18:44:16.185" v="58" actId="478"/>
          <ac:spMkLst>
            <pc:docMk/>
            <pc:sldMk cId="3454629042" sldId="268"/>
            <ac:spMk id="3" creationId="{02BC88FF-CB75-465A-A750-AA6725DD1CE1}"/>
          </ac:spMkLst>
        </pc:spChg>
        <pc:spChg chg="add mod">
          <ac:chgData name="Mulholland,Michele Marie" userId="d51c45af-8c8f-43c3-83e8-815b5b504c0b" providerId="ADAL" clId="{038F1DF6-585C-4D8D-836C-52745E3D6DE4}" dt="2021-10-27T18:46:27.211" v="178" actId="1038"/>
          <ac:spMkLst>
            <pc:docMk/>
            <pc:sldMk cId="3454629042" sldId="268"/>
            <ac:spMk id="4" creationId="{9267E764-8B51-49D4-9782-8BADE42E4914}"/>
          </ac:spMkLst>
        </pc:spChg>
        <pc:spChg chg="add mod">
          <ac:chgData name="Mulholland,Michele Marie" userId="d51c45af-8c8f-43c3-83e8-815b5b504c0b" providerId="ADAL" clId="{038F1DF6-585C-4D8D-836C-52745E3D6DE4}" dt="2021-10-27T18:46:27.211" v="178" actId="1038"/>
          <ac:spMkLst>
            <pc:docMk/>
            <pc:sldMk cId="3454629042" sldId="268"/>
            <ac:spMk id="5" creationId="{D6344324-6B65-47EC-976C-97F980E0F70C}"/>
          </ac:spMkLst>
        </pc:spChg>
        <pc:spChg chg="add mod">
          <ac:chgData name="Mulholland,Michele Marie" userId="d51c45af-8c8f-43c3-83e8-815b5b504c0b" providerId="ADAL" clId="{038F1DF6-585C-4D8D-836C-52745E3D6DE4}" dt="2021-10-27T18:47:38.118" v="232" actId="20577"/>
          <ac:spMkLst>
            <pc:docMk/>
            <pc:sldMk cId="3454629042" sldId="268"/>
            <ac:spMk id="6" creationId="{10DDD376-8D90-4670-9B9A-3886B6FCBFA6}"/>
          </ac:spMkLst>
        </pc:spChg>
        <pc:spChg chg="add mod">
          <ac:chgData name="Mulholland,Michele Marie" userId="d51c45af-8c8f-43c3-83e8-815b5b504c0b" providerId="ADAL" clId="{038F1DF6-585C-4D8D-836C-52745E3D6DE4}" dt="2021-10-27T18:47:47.936" v="235" actId="20577"/>
          <ac:spMkLst>
            <pc:docMk/>
            <pc:sldMk cId="3454629042" sldId="268"/>
            <ac:spMk id="7" creationId="{949FEB99-0FD2-4789-98B2-F00C53DC8357}"/>
          </ac:spMkLst>
        </pc:spChg>
      </pc:sldChg>
    </pc:docChg>
  </pc:docChgLst>
  <pc:docChgLst>
    <pc:chgData name="Mulholland,Michele Marie" userId="d51c45af-8c8f-43c3-83e8-815b5b504c0b" providerId="ADAL" clId="{77355E2A-AFA0-4896-9FF4-3400BA71B9D2}"/>
    <pc:docChg chg="addSld modSld">
      <pc:chgData name="Mulholland,Michele Marie" userId="d51c45af-8c8f-43c3-83e8-815b5b504c0b" providerId="ADAL" clId="{77355E2A-AFA0-4896-9FF4-3400BA71B9D2}" dt="2021-03-31T16:22:56.916" v="296" actId="1036"/>
      <pc:docMkLst>
        <pc:docMk/>
      </pc:docMkLst>
      <pc:sldChg chg="addSp delSp modSp add">
        <pc:chgData name="Mulholland,Michele Marie" userId="d51c45af-8c8f-43c3-83e8-815b5b504c0b" providerId="ADAL" clId="{77355E2A-AFA0-4896-9FF4-3400BA71B9D2}" dt="2021-03-31T16:21:33.108" v="55" actId="1036"/>
        <pc:sldMkLst>
          <pc:docMk/>
          <pc:sldMk cId="1657763827" sldId="268"/>
        </pc:sldMkLst>
        <pc:spChg chg="del">
          <ac:chgData name="Mulholland,Michele Marie" userId="d51c45af-8c8f-43c3-83e8-815b5b504c0b" providerId="ADAL" clId="{77355E2A-AFA0-4896-9FF4-3400BA71B9D2}" dt="2021-03-31T16:20:38.906" v="1"/>
          <ac:spMkLst>
            <pc:docMk/>
            <pc:sldMk cId="1657763827" sldId="268"/>
            <ac:spMk id="2" creationId="{89F7FAE6-AC8A-488F-AA93-4B966BCDB6FB}"/>
          </ac:spMkLst>
        </pc:spChg>
        <pc:spChg chg="add mod">
          <ac:chgData name="Mulholland,Michele Marie" userId="d51c45af-8c8f-43c3-83e8-815b5b504c0b" providerId="ADAL" clId="{77355E2A-AFA0-4896-9FF4-3400BA71B9D2}" dt="2021-03-31T16:20:41.684" v="4" actId="20577"/>
          <ac:spMkLst>
            <pc:docMk/>
            <pc:sldMk cId="1657763827" sldId="268"/>
            <ac:spMk id="3" creationId="{13A9C8E4-63F7-487C-9655-790062C0494C}"/>
          </ac:spMkLst>
        </pc:spChg>
        <pc:picChg chg="add mod">
          <ac:chgData name="Mulholland,Michele Marie" userId="d51c45af-8c8f-43c3-83e8-815b5b504c0b" providerId="ADAL" clId="{77355E2A-AFA0-4896-9FF4-3400BA71B9D2}" dt="2021-03-31T16:21:33.108" v="55" actId="1036"/>
          <ac:picMkLst>
            <pc:docMk/>
            <pc:sldMk cId="1657763827" sldId="268"/>
            <ac:picMk id="5" creationId="{A68F0662-62C9-4AFF-AFA5-AD4582ADEB20}"/>
          </ac:picMkLst>
        </pc:picChg>
      </pc:sldChg>
      <pc:sldChg chg="addSp modSp add">
        <pc:chgData name="Mulholland,Michele Marie" userId="d51c45af-8c8f-43c3-83e8-815b5b504c0b" providerId="ADAL" clId="{77355E2A-AFA0-4896-9FF4-3400BA71B9D2}" dt="2021-03-31T16:21:44.500" v="92" actId="1036"/>
        <pc:sldMkLst>
          <pc:docMk/>
          <pc:sldMk cId="608261986" sldId="269"/>
        </pc:sldMkLst>
        <pc:spChg chg="mod">
          <ac:chgData name="Mulholland,Michele Marie" userId="d51c45af-8c8f-43c3-83e8-815b5b504c0b" providerId="ADAL" clId="{77355E2A-AFA0-4896-9FF4-3400BA71B9D2}" dt="2021-03-31T16:20:56.836" v="9" actId="20577"/>
          <ac:spMkLst>
            <pc:docMk/>
            <pc:sldMk cId="608261986" sldId="269"/>
            <ac:spMk id="3" creationId="{13A9C8E4-63F7-487C-9655-790062C0494C}"/>
          </ac:spMkLst>
        </pc:spChg>
        <pc:picChg chg="add mod">
          <ac:chgData name="Mulholland,Michele Marie" userId="d51c45af-8c8f-43c3-83e8-815b5b504c0b" providerId="ADAL" clId="{77355E2A-AFA0-4896-9FF4-3400BA71B9D2}" dt="2021-03-31T16:21:44.500" v="92" actId="1036"/>
          <ac:picMkLst>
            <pc:docMk/>
            <pc:sldMk cId="608261986" sldId="269"/>
            <ac:picMk id="4" creationId="{6DC18C0F-54EE-4BF2-BDB2-91D63118E337}"/>
          </ac:picMkLst>
        </pc:picChg>
      </pc:sldChg>
      <pc:sldChg chg="addSp modSp add">
        <pc:chgData name="Mulholland,Michele Marie" userId="d51c45af-8c8f-43c3-83e8-815b5b504c0b" providerId="ADAL" clId="{77355E2A-AFA0-4896-9FF4-3400BA71B9D2}" dt="2021-03-31T16:21:55.604" v="121" actId="1036"/>
        <pc:sldMkLst>
          <pc:docMk/>
          <pc:sldMk cId="3641953343" sldId="270"/>
        </pc:sldMkLst>
        <pc:spChg chg="mod">
          <ac:chgData name="Mulholland,Michele Marie" userId="d51c45af-8c8f-43c3-83e8-815b5b504c0b" providerId="ADAL" clId="{77355E2A-AFA0-4896-9FF4-3400BA71B9D2}" dt="2021-03-31T16:21:00.316" v="11" actId="20577"/>
          <ac:spMkLst>
            <pc:docMk/>
            <pc:sldMk cId="3641953343" sldId="270"/>
            <ac:spMk id="3" creationId="{13A9C8E4-63F7-487C-9655-790062C0494C}"/>
          </ac:spMkLst>
        </pc:spChg>
        <pc:picChg chg="add mod">
          <ac:chgData name="Mulholland,Michele Marie" userId="d51c45af-8c8f-43c3-83e8-815b5b504c0b" providerId="ADAL" clId="{77355E2A-AFA0-4896-9FF4-3400BA71B9D2}" dt="2021-03-31T16:21:55.604" v="121" actId="1036"/>
          <ac:picMkLst>
            <pc:docMk/>
            <pc:sldMk cId="3641953343" sldId="270"/>
            <ac:picMk id="4" creationId="{A47F12AD-18A8-4D22-B2D3-2417020A32E4}"/>
          </ac:picMkLst>
        </pc:picChg>
      </pc:sldChg>
      <pc:sldChg chg="addSp modSp add">
        <pc:chgData name="Mulholland,Michele Marie" userId="d51c45af-8c8f-43c3-83e8-815b5b504c0b" providerId="ADAL" clId="{77355E2A-AFA0-4896-9FF4-3400BA71B9D2}" dt="2021-03-31T16:22:05.986" v="144" actId="1036"/>
        <pc:sldMkLst>
          <pc:docMk/>
          <pc:sldMk cId="3874127672" sldId="271"/>
        </pc:sldMkLst>
        <pc:spChg chg="mod">
          <ac:chgData name="Mulholland,Michele Marie" userId="d51c45af-8c8f-43c3-83e8-815b5b504c0b" providerId="ADAL" clId="{77355E2A-AFA0-4896-9FF4-3400BA71B9D2}" dt="2021-03-31T16:21:04.820" v="13" actId="20577"/>
          <ac:spMkLst>
            <pc:docMk/>
            <pc:sldMk cId="3874127672" sldId="271"/>
            <ac:spMk id="3" creationId="{13A9C8E4-63F7-487C-9655-790062C0494C}"/>
          </ac:spMkLst>
        </pc:spChg>
        <pc:picChg chg="add mod">
          <ac:chgData name="Mulholland,Michele Marie" userId="d51c45af-8c8f-43c3-83e8-815b5b504c0b" providerId="ADAL" clId="{77355E2A-AFA0-4896-9FF4-3400BA71B9D2}" dt="2021-03-31T16:22:05.986" v="144" actId="1036"/>
          <ac:picMkLst>
            <pc:docMk/>
            <pc:sldMk cId="3874127672" sldId="271"/>
            <ac:picMk id="4" creationId="{4118290B-1F95-4D73-8869-6E43EDC2A552}"/>
          </ac:picMkLst>
        </pc:picChg>
      </pc:sldChg>
      <pc:sldChg chg="addSp modSp add">
        <pc:chgData name="Mulholland,Michele Marie" userId="d51c45af-8c8f-43c3-83e8-815b5b504c0b" providerId="ADAL" clId="{77355E2A-AFA0-4896-9FF4-3400BA71B9D2}" dt="2021-03-31T16:22:21.188" v="197" actId="1035"/>
        <pc:sldMkLst>
          <pc:docMk/>
          <pc:sldMk cId="102910821" sldId="272"/>
        </pc:sldMkLst>
        <pc:spChg chg="mod">
          <ac:chgData name="Mulholland,Michele Marie" userId="d51c45af-8c8f-43c3-83e8-815b5b504c0b" providerId="ADAL" clId="{77355E2A-AFA0-4896-9FF4-3400BA71B9D2}" dt="2021-03-31T16:21:09.620" v="15" actId="20577"/>
          <ac:spMkLst>
            <pc:docMk/>
            <pc:sldMk cId="102910821" sldId="272"/>
            <ac:spMk id="3" creationId="{13A9C8E4-63F7-487C-9655-790062C0494C}"/>
          </ac:spMkLst>
        </pc:spChg>
        <pc:picChg chg="add mod">
          <ac:chgData name="Mulholland,Michele Marie" userId="d51c45af-8c8f-43c3-83e8-815b5b504c0b" providerId="ADAL" clId="{77355E2A-AFA0-4896-9FF4-3400BA71B9D2}" dt="2021-03-31T16:22:21.188" v="197" actId="1035"/>
          <ac:picMkLst>
            <pc:docMk/>
            <pc:sldMk cId="102910821" sldId="272"/>
            <ac:picMk id="4" creationId="{D2C62853-3D3B-4E5B-B0B9-82B855C643D0}"/>
          </ac:picMkLst>
        </pc:picChg>
      </pc:sldChg>
      <pc:sldChg chg="addSp modSp add">
        <pc:chgData name="Mulholland,Michele Marie" userId="d51c45af-8c8f-43c3-83e8-815b5b504c0b" providerId="ADAL" clId="{77355E2A-AFA0-4896-9FF4-3400BA71B9D2}" dt="2021-03-31T16:22:33.020" v="239" actId="1036"/>
        <pc:sldMkLst>
          <pc:docMk/>
          <pc:sldMk cId="1038734086" sldId="273"/>
        </pc:sldMkLst>
        <pc:spChg chg="mod">
          <ac:chgData name="Mulholland,Michele Marie" userId="d51c45af-8c8f-43c3-83e8-815b5b504c0b" providerId="ADAL" clId="{77355E2A-AFA0-4896-9FF4-3400BA71B9D2}" dt="2021-03-31T16:21:12.996" v="17" actId="20577"/>
          <ac:spMkLst>
            <pc:docMk/>
            <pc:sldMk cId="1038734086" sldId="273"/>
            <ac:spMk id="3" creationId="{13A9C8E4-63F7-487C-9655-790062C0494C}"/>
          </ac:spMkLst>
        </pc:spChg>
        <pc:picChg chg="add mod">
          <ac:chgData name="Mulholland,Michele Marie" userId="d51c45af-8c8f-43c3-83e8-815b5b504c0b" providerId="ADAL" clId="{77355E2A-AFA0-4896-9FF4-3400BA71B9D2}" dt="2021-03-31T16:22:33.020" v="239" actId="1036"/>
          <ac:picMkLst>
            <pc:docMk/>
            <pc:sldMk cId="1038734086" sldId="273"/>
            <ac:picMk id="4" creationId="{8468869E-45DB-485D-9F23-F2240B07E2ED}"/>
          </ac:picMkLst>
        </pc:picChg>
      </pc:sldChg>
      <pc:sldChg chg="addSp modSp add">
        <pc:chgData name="Mulholland,Michele Marie" userId="d51c45af-8c8f-43c3-83e8-815b5b504c0b" providerId="ADAL" clId="{77355E2A-AFA0-4896-9FF4-3400BA71B9D2}" dt="2021-03-31T16:22:44.236" v="265" actId="1036"/>
        <pc:sldMkLst>
          <pc:docMk/>
          <pc:sldMk cId="4182132054" sldId="274"/>
        </pc:sldMkLst>
        <pc:spChg chg="mod">
          <ac:chgData name="Mulholland,Michele Marie" userId="d51c45af-8c8f-43c3-83e8-815b5b504c0b" providerId="ADAL" clId="{77355E2A-AFA0-4896-9FF4-3400BA71B9D2}" dt="2021-03-31T16:21:17.060" v="19" actId="20577"/>
          <ac:spMkLst>
            <pc:docMk/>
            <pc:sldMk cId="4182132054" sldId="274"/>
            <ac:spMk id="3" creationId="{13A9C8E4-63F7-487C-9655-790062C0494C}"/>
          </ac:spMkLst>
        </pc:spChg>
        <pc:picChg chg="add mod">
          <ac:chgData name="Mulholland,Michele Marie" userId="d51c45af-8c8f-43c3-83e8-815b5b504c0b" providerId="ADAL" clId="{77355E2A-AFA0-4896-9FF4-3400BA71B9D2}" dt="2021-03-31T16:22:44.236" v="265" actId="1036"/>
          <ac:picMkLst>
            <pc:docMk/>
            <pc:sldMk cId="4182132054" sldId="274"/>
            <ac:picMk id="4" creationId="{471F9C54-038E-4B54-AAFC-7DB2EAB6482A}"/>
          </ac:picMkLst>
        </pc:picChg>
      </pc:sldChg>
      <pc:sldChg chg="addSp modSp add">
        <pc:chgData name="Mulholland,Michele Marie" userId="d51c45af-8c8f-43c3-83e8-815b5b504c0b" providerId="ADAL" clId="{77355E2A-AFA0-4896-9FF4-3400BA71B9D2}" dt="2021-03-31T16:22:56.916" v="296" actId="1036"/>
        <pc:sldMkLst>
          <pc:docMk/>
          <pc:sldMk cId="3978765488" sldId="275"/>
        </pc:sldMkLst>
        <pc:spChg chg="mod">
          <ac:chgData name="Mulholland,Michele Marie" userId="d51c45af-8c8f-43c3-83e8-815b5b504c0b" providerId="ADAL" clId="{77355E2A-AFA0-4896-9FF4-3400BA71B9D2}" dt="2021-03-31T16:21:20.260" v="21" actId="20577"/>
          <ac:spMkLst>
            <pc:docMk/>
            <pc:sldMk cId="3978765488" sldId="275"/>
            <ac:spMk id="3" creationId="{13A9C8E4-63F7-487C-9655-790062C0494C}"/>
          </ac:spMkLst>
        </pc:spChg>
        <pc:picChg chg="add mod">
          <ac:chgData name="Mulholland,Michele Marie" userId="d51c45af-8c8f-43c3-83e8-815b5b504c0b" providerId="ADAL" clId="{77355E2A-AFA0-4896-9FF4-3400BA71B9D2}" dt="2021-03-31T16:22:56.916" v="296" actId="1036"/>
          <ac:picMkLst>
            <pc:docMk/>
            <pc:sldMk cId="3978765488" sldId="275"/>
            <ac:picMk id="4" creationId="{858447A7-1DA3-4235-B720-8729C07BEF45}"/>
          </ac:picMkLst>
        </pc:picChg>
      </pc:sldChg>
    </pc:docChg>
  </pc:docChgLst>
  <pc:docChgLst>
    <pc:chgData name="Mulholland,Michele Marie" userId="d51c45af-8c8f-43c3-83e8-815b5b504c0b" providerId="ADAL" clId="{6BFF7928-83F0-45BC-AC2A-ED29C33B921D}"/>
    <pc:docChg chg="modSld">
      <pc:chgData name="Mulholland,Michele Marie" userId="d51c45af-8c8f-43c3-83e8-815b5b504c0b" providerId="ADAL" clId="{6BFF7928-83F0-45BC-AC2A-ED29C33B921D}" dt="2021-12-08T13:57:03.871" v="1" actId="20577"/>
      <pc:docMkLst>
        <pc:docMk/>
      </pc:docMkLst>
      <pc:sldChg chg="modSp">
        <pc:chgData name="Mulholland,Michele Marie" userId="d51c45af-8c8f-43c3-83e8-815b5b504c0b" providerId="ADAL" clId="{6BFF7928-83F0-45BC-AC2A-ED29C33B921D}" dt="2021-12-08T13:57:03.871" v="1" actId="20577"/>
        <pc:sldMkLst>
          <pc:docMk/>
          <pc:sldMk cId="3454629042" sldId="268"/>
        </pc:sldMkLst>
        <pc:spChg chg="mod">
          <ac:chgData name="Mulholland,Michele Marie" userId="d51c45af-8c8f-43c3-83e8-815b5b504c0b" providerId="ADAL" clId="{6BFF7928-83F0-45BC-AC2A-ED29C33B921D}" dt="2021-12-08T13:57:03.871" v="1" actId="20577"/>
          <ac:spMkLst>
            <pc:docMk/>
            <pc:sldMk cId="3454629042" sldId="268"/>
            <ac:spMk id="7" creationId="{949FEB99-0FD2-4789-98B2-F00C53DC8357}"/>
          </ac:spMkLst>
        </pc:spChg>
      </pc:sldChg>
    </pc:docChg>
  </pc:docChgLst>
  <pc:docChgLst>
    <pc:chgData name="Mulholland,Michele Marie" userId="d51c45af-8c8f-43c3-83e8-815b5b504c0b" providerId="ADAL" clId="{B1796739-1012-4535-A1B5-6B1FCD8D6C72}"/>
    <pc:docChg chg="delSld">
      <pc:chgData name="Mulholland,Michele Marie" userId="d51c45af-8c8f-43c3-83e8-815b5b504c0b" providerId="ADAL" clId="{B1796739-1012-4535-A1B5-6B1FCD8D6C72}" dt="2021-08-17T18:06:27.747" v="7" actId="2696"/>
      <pc:docMkLst>
        <pc:docMk/>
      </pc:docMkLst>
      <pc:sldChg chg="del">
        <pc:chgData name="Mulholland,Michele Marie" userId="d51c45af-8c8f-43c3-83e8-815b5b504c0b" providerId="ADAL" clId="{B1796739-1012-4535-A1B5-6B1FCD8D6C72}" dt="2021-08-17T18:06:27.716" v="0" actId="2696"/>
        <pc:sldMkLst>
          <pc:docMk/>
          <pc:sldMk cId="1657763827" sldId="268"/>
        </pc:sldMkLst>
      </pc:sldChg>
      <pc:sldChg chg="del">
        <pc:chgData name="Mulholland,Michele Marie" userId="d51c45af-8c8f-43c3-83e8-815b5b504c0b" providerId="ADAL" clId="{B1796739-1012-4535-A1B5-6B1FCD8D6C72}" dt="2021-08-17T18:06:27.732" v="1" actId="2696"/>
        <pc:sldMkLst>
          <pc:docMk/>
          <pc:sldMk cId="608261986" sldId="269"/>
        </pc:sldMkLst>
      </pc:sldChg>
      <pc:sldChg chg="del">
        <pc:chgData name="Mulholland,Michele Marie" userId="d51c45af-8c8f-43c3-83e8-815b5b504c0b" providerId="ADAL" clId="{B1796739-1012-4535-A1B5-6B1FCD8D6C72}" dt="2021-08-17T18:06:27.732" v="2" actId="2696"/>
        <pc:sldMkLst>
          <pc:docMk/>
          <pc:sldMk cId="3641953343" sldId="270"/>
        </pc:sldMkLst>
      </pc:sldChg>
      <pc:sldChg chg="del">
        <pc:chgData name="Mulholland,Michele Marie" userId="d51c45af-8c8f-43c3-83e8-815b5b504c0b" providerId="ADAL" clId="{B1796739-1012-4535-A1B5-6B1FCD8D6C72}" dt="2021-08-17T18:06:27.732" v="3" actId="2696"/>
        <pc:sldMkLst>
          <pc:docMk/>
          <pc:sldMk cId="3874127672" sldId="271"/>
        </pc:sldMkLst>
      </pc:sldChg>
      <pc:sldChg chg="del">
        <pc:chgData name="Mulholland,Michele Marie" userId="d51c45af-8c8f-43c3-83e8-815b5b504c0b" providerId="ADAL" clId="{B1796739-1012-4535-A1B5-6B1FCD8D6C72}" dt="2021-08-17T18:06:27.732" v="4" actId="2696"/>
        <pc:sldMkLst>
          <pc:docMk/>
          <pc:sldMk cId="102910821" sldId="272"/>
        </pc:sldMkLst>
      </pc:sldChg>
      <pc:sldChg chg="del">
        <pc:chgData name="Mulholland,Michele Marie" userId="d51c45af-8c8f-43c3-83e8-815b5b504c0b" providerId="ADAL" clId="{B1796739-1012-4535-A1B5-6B1FCD8D6C72}" dt="2021-08-17T18:06:27.732" v="5" actId="2696"/>
        <pc:sldMkLst>
          <pc:docMk/>
          <pc:sldMk cId="1038734086" sldId="273"/>
        </pc:sldMkLst>
      </pc:sldChg>
      <pc:sldChg chg="del">
        <pc:chgData name="Mulholland,Michele Marie" userId="d51c45af-8c8f-43c3-83e8-815b5b504c0b" providerId="ADAL" clId="{B1796739-1012-4535-A1B5-6B1FCD8D6C72}" dt="2021-08-17T18:06:27.747" v="6" actId="2696"/>
        <pc:sldMkLst>
          <pc:docMk/>
          <pc:sldMk cId="4182132054" sldId="274"/>
        </pc:sldMkLst>
      </pc:sldChg>
      <pc:sldChg chg="del">
        <pc:chgData name="Mulholland,Michele Marie" userId="d51c45af-8c8f-43c3-83e8-815b5b504c0b" providerId="ADAL" clId="{B1796739-1012-4535-A1B5-6B1FCD8D6C72}" dt="2021-08-17T18:06:27.747" v="7" actId="2696"/>
        <pc:sldMkLst>
          <pc:docMk/>
          <pc:sldMk cId="3978765488" sldId="275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1431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7153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036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617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94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387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195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797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593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424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532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173ABB-B4C6-0643-87DA-16BB281F1F35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79D83C-79EB-2B42-AE4C-E1D498F5DA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561602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886A07-7D58-44A4-AB4A-C19E3F518A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boon Source-Based Morphometry Component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267E764-8B51-49D4-9782-8BADE42E4914}"/>
              </a:ext>
            </a:extLst>
          </p:cNvPr>
          <p:cNvSpPr/>
          <p:nvPr/>
        </p:nvSpPr>
        <p:spPr>
          <a:xfrm>
            <a:off x="3363536" y="3152775"/>
            <a:ext cx="781050" cy="619125"/>
          </a:xfrm>
          <a:prstGeom prst="rect">
            <a:avLst/>
          </a:prstGeom>
          <a:solidFill>
            <a:srgbClr val="6AF2EF"/>
          </a:solidFill>
          <a:ln>
            <a:solidFill>
              <a:srgbClr val="6AF2E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6344324-6B65-47EC-976C-97F980E0F70C}"/>
              </a:ext>
            </a:extLst>
          </p:cNvPr>
          <p:cNvSpPr/>
          <p:nvPr/>
        </p:nvSpPr>
        <p:spPr>
          <a:xfrm>
            <a:off x="3363536" y="4344266"/>
            <a:ext cx="781050" cy="619125"/>
          </a:xfrm>
          <a:prstGeom prst="rect">
            <a:avLst/>
          </a:prstGeom>
          <a:solidFill>
            <a:schemeClr val="accent6"/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0DDD376-8D90-4670-9B9A-3886B6FCBFA6}"/>
              </a:ext>
            </a:extLst>
          </p:cNvPr>
          <p:cNvSpPr txBox="1"/>
          <p:nvPr/>
        </p:nvSpPr>
        <p:spPr>
          <a:xfrm>
            <a:off x="4372493" y="3231504"/>
            <a:ext cx="40095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Regions with z-scores ≥ 3.0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49FEB99-0FD2-4789-98B2-F00C53DC8357}"/>
              </a:ext>
            </a:extLst>
          </p:cNvPr>
          <p:cNvSpPr txBox="1"/>
          <p:nvPr/>
        </p:nvSpPr>
        <p:spPr>
          <a:xfrm>
            <a:off x="4372493" y="4422995"/>
            <a:ext cx="40095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Regions with </a:t>
            </a:r>
            <a:r>
              <a:rPr lang="en-US" sz="2400"/>
              <a:t>z-scores ≤ -</a:t>
            </a:r>
            <a:r>
              <a:rPr lang="en-US" sz="2400" dirty="0"/>
              <a:t>3.00</a:t>
            </a:r>
          </a:p>
        </p:txBody>
      </p:sp>
    </p:spTree>
    <p:extLst>
      <p:ext uri="{BB962C8B-B14F-4D97-AF65-F5344CB8AC3E}">
        <p14:creationId xmlns:p14="http://schemas.microsoft.com/office/powerpoint/2010/main" val="345462904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8FFBF9-6982-1048-B9AF-B259249EAF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 9</a:t>
            </a:r>
          </a:p>
        </p:txBody>
      </p:sp>
      <p:pic>
        <p:nvPicPr>
          <p:cNvPr id="4" name="Picture 3" descr="A picture containing dark, night&#10;&#10;Description automatically generated">
            <a:extLst>
              <a:ext uri="{FF2B5EF4-FFF2-40B4-BE49-F238E27FC236}">
                <a16:creationId xmlns:a16="http://schemas.microsoft.com/office/drawing/2014/main" id="{2A5F2503-F5B9-4C43-8DCD-23235FA7DD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98660" y="1879600"/>
            <a:ext cx="9817100" cy="497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525841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4AB358-8ED0-5042-BE28-7891DC2BC5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 10</a:t>
            </a:r>
          </a:p>
        </p:txBody>
      </p:sp>
      <p:pic>
        <p:nvPicPr>
          <p:cNvPr id="4" name="Picture 3" descr="A picture containing dark, decorated&#10;&#10;Description automatically generated">
            <a:extLst>
              <a:ext uri="{FF2B5EF4-FFF2-40B4-BE49-F238E27FC236}">
                <a16:creationId xmlns:a16="http://schemas.microsoft.com/office/drawing/2014/main" id="{2343D794-EA92-FA48-AEA1-8767D9678C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450" y="1917700"/>
            <a:ext cx="9817100" cy="4940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54647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C01CB2-6B44-1849-A6AA-AB7697E624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 1</a:t>
            </a:r>
          </a:p>
        </p:txBody>
      </p:sp>
      <p:pic>
        <p:nvPicPr>
          <p:cNvPr id="4" name="Picture 3" descr="A picture containing dark, several&#10;&#10;Description automatically generated">
            <a:extLst>
              <a:ext uri="{FF2B5EF4-FFF2-40B4-BE49-F238E27FC236}">
                <a16:creationId xmlns:a16="http://schemas.microsoft.com/office/drawing/2014/main" id="{989F596A-BE09-5745-9F42-2519BF051B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1750" y="1832191"/>
            <a:ext cx="9588500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03306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D14374-8EA8-1241-8517-669206CB94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 2</a:t>
            </a:r>
          </a:p>
        </p:txBody>
      </p:sp>
      <p:pic>
        <p:nvPicPr>
          <p:cNvPr id="4" name="Picture 3" descr="A picture containing dark, lit&#10;&#10;Description automatically generated">
            <a:extLst>
              <a:ext uri="{FF2B5EF4-FFF2-40B4-BE49-F238E27FC236}">
                <a16:creationId xmlns:a16="http://schemas.microsoft.com/office/drawing/2014/main" id="{339280E2-D130-1644-8B21-51C02F0D94E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01750" y="1816452"/>
            <a:ext cx="9588500" cy="50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83544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A3D5D-CF4A-7846-9CE1-9BE20F52EB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 3</a:t>
            </a:r>
          </a:p>
        </p:txBody>
      </p:sp>
      <p:pic>
        <p:nvPicPr>
          <p:cNvPr id="4" name="Picture 3" descr="A picture containing dark, lit, light&#10;&#10;Description automatically generated">
            <a:extLst>
              <a:ext uri="{FF2B5EF4-FFF2-40B4-BE49-F238E27FC236}">
                <a16:creationId xmlns:a16="http://schemas.microsoft.com/office/drawing/2014/main" id="{4D2DEE90-2C08-4240-9D87-26A26382C9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01750" y="1913113"/>
            <a:ext cx="9588500" cy="492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8500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8FEC6C-F6BE-8B43-A455-0FC1EA52C3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 4</a:t>
            </a:r>
          </a:p>
        </p:txBody>
      </p:sp>
      <p:pic>
        <p:nvPicPr>
          <p:cNvPr id="4" name="Picture 3" descr="A picture containing dark, several&#10;&#10;Description automatically generated">
            <a:extLst>
              <a:ext uri="{FF2B5EF4-FFF2-40B4-BE49-F238E27FC236}">
                <a16:creationId xmlns:a16="http://schemas.microsoft.com/office/drawing/2014/main" id="{8EE5799F-E626-FA4D-AEF0-FCDC0AEEC3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5250" y="1955800"/>
            <a:ext cx="9461500" cy="4902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74091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1CED3E-4316-854A-A74C-8D8AADFE16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 5</a:t>
            </a:r>
          </a:p>
        </p:txBody>
      </p:sp>
      <p:pic>
        <p:nvPicPr>
          <p:cNvPr id="4" name="Picture 3" descr="A picture containing dark, light, lit&#10;&#10;Description automatically generated">
            <a:extLst>
              <a:ext uri="{FF2B5EF4-FFF2-40B4-BE49-F238E27FC236}">
                <a16:creationId xmlns:a16="http://schemas.microsoft.com/office/drawing/2014/main" id="{3882E9CB-6AF2-744A-89A2-BB75BDF057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6954" y="1943100"/>
            <a:ext cx="9575800" cy="4914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32128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AB083C-8529-8A4F-AF03-15E8060F45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 6</a:t>
            </a:r>
          </a:p>
        </p:txBody>
      </p:sp>
      <p:pic>
        <p:nvPicPr>
          <p:cNvPr id="4" name="Picture 3" descr="A picture containing dark, several&#10;&#10;Description automatically generated">
            <a:extLst>
              <a:ext uri="{FF2B5EF4-FFF2-40B4-BE49-F238E27FC236}">
                <a16:creationId xmlns:a16="http://schemas.microsoft.com/office/drawing/2014/main" id="{A5756E3B-B051-4843-9278-6B33361AA5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6611" y="1917700"/>
            <a:ext cx="9601200" cy="4940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43185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F3A776-3AC7-0340-8912-CB5A3CA1CE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 7</a:t>
            </a:r>
          </a:p>
        </p:txBody>
      </p:sp>
      <p:pic>
        <p:nvPicPr>
          <p:cNvPr id="4" name="Picture 3" descr="A picture containing dark&#10;&#10;Description automatically generated">
            <a:extLst>
              <a:ext uri="{FF2B5EF4-FFF2-40B4-BE49-F238E27FC236}">
                <a16:creationId xmlns:a16="http://schemas.microsoft.com/office/drawing/2014/main" id="{55117313-3768-6545-8AFD-6485398578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89050" y="2019300"/>
            <a:ext cx="9613900" cy="4838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08227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780EF8-B529-5949-9F5C-F669B9F630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onent 8</a:t>
            </a:r>
          </a:p>
        </p:txBody>
      </p:sp>
      <p:pic>
        <p:nvPicPr>
          <p:cNvPr id="4" name="Picture 3" descr="A group of jellyfish&#10;&#10;Description automatically generated with low confidence">
            <a:extLst>
              <a:ext uri="{FF2B5EF4-FFF2-40B4-BE49-F238E27FC236}">
                <a16:creationId xmlns:a16="http://schemas.microsoft.com/office/drawing/2014/main" id="{73109032-75B7-7649-8FF4-01FE179311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1900" y="1905000"/>
            <a:ext cx="9728200" cy="4953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2469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29AF8C"/>
      </a:accent1>
      <a:accent2>
        <a:srgbClr val="97BE49"/>
      </a:accent2>
      <a:accent3>
        <a:srgbClr val="3D9CCC"/>
      </a:accent3>
      <a:accent4>
        <a:srgbClr val="7C60C6"/>
      </a:accent4>
      <a:accent5>
        <a:srgbClr val="C9492C"/>
      </a:accent5>
      <a:accent6>
        <a:srgbClr val="D58C2E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3E4F19A7-A959-40BB-972C-4880BAF8EB09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35</Words>
  <Application>Microsoft Office PowerPoint</Application>
  <PresentationFormat>Widescreen</PresentationFormat>
  <Paragraphs>13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Baboon Source-Based Morphometry Components</vt:lpstr>
      <vt:lpstr>Component 1</vt:lpstr>
      <vt:lpstr>Component 2</vt:lpstr>
      <vt:lpstr>Component 3</vt:lpstr>
      <vt:lpstr>Component 4</vt:lpstr>
      <vt:lpstr>Component 5</vt:lpstr>
      <vt:lpstr>Component 6</vt:lpstr>
      <vt:lpstr>Component 7</vt:lpstr>
      <vt:lpstr>Component 8</vt:lpstr>
      <vt:lpstr>Component 9</vt:lpstr>
      <vt:lpstr>Component 10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ponent 1</dc:title>
  <dc:creator>Mulholland,Michele Marie</dc:creator>
  <cp:lastModifiedBy>Mulholland,Michele Marie</cp:lastModifiedBy>
  <cp:revision>1</cp:revision>
  <dcterms:created xsi:type="dcterms:W3CDTF">2021-03-26T21:04:48Z</dcterms:created>
  <dcterms:modified xsi:type="dcterms:W3CDTF">2021-12-08T13:57:08Z</dcterms:modified>
</cp:coreProperties>
</file>